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0" r:id="rId2"/>
  </p:sldIdLst>
  <p:sldSz cx="8999538" cy="10799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8F8F"/>
    <a:srgbClr val="00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78000" autoAdjust="0"/>
  </p:normalViewPr>
  <p:slideViewPr>
    <p:cSldViewPr snapToGrid="0">
      <p:cViewPr varScale="1">
        <p:scale>
          <a:sx n="64" d="100"/>
          <a:sy n="64" d="100"/>
        </p:scale>
        <p:origin x="303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6C5750D-8F90-4B48-B559-AAB81ADD9BE1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143000"/>
            <a:ext cx="25717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5127F41-C56B-49E7-880F-D65773FB2FB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63229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wikipathways.org/pathways" TargetMode="External"/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143125" y="1143000"/>
            <a:ext cx="2571750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noProof="0" dirty="0">
                <a:latin typeface="Arial" panose="020B0604020202020204" pitchFamily="34" charset="0"/>
                <a:cs typeface="Arial" panose="020B0604020202020204" pitchFamily="34" charset="0"/>
              </a:rPr>
              <a:t>Figure S5. Proteins up- or downregulated </a:t>
            </a:r>
            <a:r>
              <a:rPr lang="en-US" sz="1200" b="1" noProof="0">
                <a:latin typeface="Arial" panose="020B0604020202020204" pitchFamily="34" charset="0"/>
                <a:cs typeface="Arial" panose="020B0604020202020204" pitchFamily="34" charset="0"/>
              </a:rPr>
              <a:t>in ATTR EVs in </a:t>
            </a:r>
            <a:r>
              <a:rPr lang="en-US" sz="1200" b="1" noProof="0" dirty="0">
                <a:latin typeface="Arial" panose="020B0604020202020204" pitchFamily="34" charset="0"/>
                <a:cs typeface="Arial" panose="020B0604020202020204" pitchFamily="34" charset="0"/>
              </a:rPr>
              <a:t>the complement and coagulation cascades </a:t>
            </a:r>
            <a:r>
              <a:rPr lang="en-US" sz="1200" noProof="0" dirty="0">
                <a:latin typeface="Arial" panose="020B0604020202020204" pitchFamily="34" charset="0"/>
                <a:cs typeface="Arial" panose="020B0604020202020204" pitchFamily="34" charset="0"/>
              </a:rPr>
              <a:t>(WP558 - </a:t>
            </a:r>
            <a:r>
              <a:rPr lang="en-US" sz="1200" i="1" noProof="0" dirty="0">
                <a:latin typeface="Arial" panose="020B0604020202020204" pitchFamily="34" charset="0"/>
                <a:cs typeface="Arial" panose="020B0604020202020204" pitchFamily="34" charset="0"/>
              </a:rPr>
              <a:t>Homo sapiens - version 2024-07-22) </a:t>
            </a:r>
            <a:r>
              <a:rPr lang="en-US" sz="1200" b="1" i="0" noProof="0" dirty="0">
                <a:latin typeface="Arial" panose="020B0604020202020204" pitchFamily="34" charset="0"/>
                <a:cs typeface="Arial" panose="020B0604020202020204" pitchFamily="34" charset="0"/>
              </a:rPr>
              <a:t>and the</a:t>
            </a:r>
            <a:r>
              <a:rPr lang="en-US" sz="1200" b="1" i="1" noProof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noProof="0" dirty="0">
                <a:latin typeface="Arial" panose="020B0604020202020204" pitchFamily="34" charset="0"/>
                <a:cs typeface="Arial" panose="020B0604020202020204" pitchFamily="34" charset="0"/>
              </a:rPr>
              <a:t>blood clotting cascade </a:t>
            </a:r>
            <a:r>
              <a:rPr lang="en-US" sz="1200" noProof="0" dirty="0">
                <a:latin typeface="Arial" panose="020B0604020202020204" pitchFamily="34" charset="0"/>
                <a:cs typeface="Arial" panose="020B0604020202020204" pitchFamily="34" charset="0"/>
              </a:rPr>
              <a:t>(WP272 - </a:t>
            </a:r>
            <a:r>
              <a:rPr lang="en-US" sz="1200" i="1" noProof="0" dirty="0">
                <a:latin typeface="Arial" panose="020B0604020202020204" pitchFamily="34" charset="0"/>
                <a:cs typeface="Arial" panose="020B0604020202020204" pitchFamily="34" charset="0"/>
              </a:rPr>
              <a:t>Homo sapiens - version 2023-11-25) (</a:t>
            </a:r>
            <a:r>
              <a:rPr lang="en-US" sz="1200" i="1" noProof="0" dirty="0" err="1">
                <a:latin typeface="Arial" panose="020B0604020202020204" pitchFamily="34" charset="0"/>
                <a:cs typeface="Arial" panose="020B0604020202020204" pitchFamily="34" charset="0"/>
              </a:rPr>
              <a:t>wikipathway</a:t>
            </a:r>
            <a:r>
              <a:rPr lang="en-US" sz="1200" i="1" noProof="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200" i="1" noProof="0" dirty="0">
                <a:latin typeface="Arial" panose="020B0604020202020204" pitchFamily="34" charset="0"/>
                <a:cs typeface="Arial" panose="020B0604020202020204" pitchFamily="34" charset="0"/>
                <a:hlinkClick r:id="rId3"/>
              </a:rPr>
              <a:t>https://www.wikipathways.org/pathways</a:t>
            </a:r>
            <a:r>
              <a:rPr lang="en-US" sz="1200" i="1" noProof="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sz="1200" noProof="0" dirty="0">
                <a:latin typeface="Arial" panose="020B0604020202020204" pitchFamily="34" charset="0"/>
                <a:cs typeface="Arial" panose="020B0604020202020204" pitchFamily="34" charset="0"/>
              </a:rPr>
              <a:t>Proteins upregulated in EVs from ATTR patients (relative to nonamyloid cardiomyopathy patients) are highlighted in red, while the proteins that are downregulated in ATTR patients are highlighted in blue.</a:t>
            </a:r>
          </a:p>
          <a:p>
            <a:endParaRPr lang="en-US" noProof="0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5127F41-C56B-49E7-880F-D65773FB2FB4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53998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1767462"/>
            <a:ext cx="7649607" cy="3759917"/>
          </a:xfrm>
        </p:spPr>
        <p:txBody>
          <a:bodyPr anchor="b"/>
          <a:lstStyle>
            <a:lvl1pPr algn="ctr">
              <a:defRPr sz="590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5672376"/>
            <a:ext cx="6749654" cy="2607442"/>
          </a:xfrm>
        </p:spPr>
        <p:txBody>
          <a:bodyPr/>
          <a:lstStyle>
            <a:lvl1pPr marL="0" indent="0" algn="ctr">
              <a:buNone/>
              <a:defRPr sz="2362"/>
            </a:lvl1pPr>
            <a:lvl2pPr marL="449976" indent="0" algn="ctr">
              <a:buNone/>
              <a:defRPr sz="1968"/>
            </a:lvl2pPr>
            <a:lvl3pPr marL="899952" indent="0" algn="ctr">
              <a:buNone/>
              <a:defRPr sz="1772"/>
            </a:lvl3pPr>
            <a:lvl4pPr marL="1349929" indent="0" algn="ctr">
              <a:buNone/>
              <a:defRPr sz="1575"/>
            </a:lvl4pPr>
            <a:lvl5pPr marL="1799905" indent="0" algn="ctr">
              <a:buNone/>
              <a:defRPr sz="1575"/>
            </a:lvl5pPr>
            <a:lvl6pPr marL="2249881" indent="0" algn="ctr">
              <a:buNone/>
              <a:defRPr sz="1575"/>
            </a:lvl6pPr>
            <a:lvl7pPr marL="2699857" indent="0" algn="ctr">
              <a:buNone/>
              <a:defRPr sz="1575"/>
            </a:lvl7pPr>
            <a:lvl8pPr marL="3149834" indent="0" algn="ctr">
              <a:buNone/>
              <a:defRPr sz="1575"/>
            </a:lvl8pPr>
            <a:lvl9pPr marL="3599810" indent="0" algn="ctr">
              <a:buNone/>
              <a:defRPr sz="1575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E4063-BBB1-40F4-A53A-C65A7728EA7C}" type="datetimeFigureOut">
              <a:rPr lang="fr-FR" smtClean="0"/>
              <a:t>28/05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A5048-FCB2-40E4-A0D8-01988A8FF9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43389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E4063-BBB1-40F4-A53A-C65A7728EA7C}" type="datetimeFigureOut">
              <a:rPr lang="fr-FR" smtClean="0"/>
              <a:t>28/05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A5048-FCB2-40E4-A0D8-01988A8FF9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370174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574987"/>
            <a:ext cx="1940525" cy="9152300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9" y="574987"/>
            <a:ext cx="5709082" cy="915230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E4063-BBB1-40F4-A53A-C65A7728EA7C}" type="datetimeFigureOut">
              <a:rPr lang="fr-FR" smtClean="0"/>
              <a:t>28/05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A5048-FCB2-40E4-A0D8-01988A8FF9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590106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E4063-BBB1-40F4-A53A-C65A7728EA7C}" type="datetimeFigureOut">
              <a:rPr lang="fr-FR" smtClean="0"/>
              <a:t>28/05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A5048-FCB2-40E4-A0D8-01988A8FF9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97719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2692444"/>
            <a:ext cx="7762102" cy="4492401"/>
          </a:xfrm>
        </p:spPr>
        <p:txBody>
          <a:bodyPr anchor="b"/>
          <a:lstStyle>
            <a:lvl1pPr>
              <a:defRPr sz="590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7227345"/>
            <a:ext cx="7762102" cy="2362447"/>
          </a:xfrm>
        </p:spPr>
        <p:txBody>
          <a:bodyPr/>
          <a:lstStyle>
            <a:lvl1pPr marL="0" indent="0">
              <a:buNone/>
              <a:defRPr sz="2362">
                <a:solidFill>
                  <a:schemeClr val="tx1"/>
                </a:solidFill>
              </a:defRPr>
            </a:lvl1pPr>
            <a:lvl2pPr marL="449976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2pPr>
            <a:lvl3pPr marL="899952" indent="0">
              <a:buNone/>
              <a:defRPr sz="1772">
                <a:solidFill>
                  <a:schemeClr val="tx1">
                    <a:tint val="75000"/>
                  </a:schemeClr>
                </a:solidFill>
              </a:defRPr>
            </a:lvl3pPr>
            <a:lvl4pPr marL="1349929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4pPr>
            <a:lvl5pPr marL="179990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5pPr>
            <a:lvl6pPr marL="2249881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6pPr>
            <a:lvl7pPr marL="2699857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7pPr>
            <a:lvl8pPr marL="314983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8pPr>
            <a:lvl9pPr marL="3599810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E4063-BBB1-40F4-A53A-C65A7728EA7C}" type="datetimeFigureOut">
              <a:rPr lang="fr-FR" smtClean="0"/>
              <a:t>28/05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A5048-FCB2-40E4-A0D8-01988A8FF9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184524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2874937"/>
            <a:ext cx="3824804" cy="6852350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2874937"/>
            <a:ext cx="3824804" cy="6852350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E4063-BBB1-40F4-A53A-C65A7728EA7C}" type="datetimeFigureOut">
              <a:rPr lang="fr-FR" smtClean="0"/>
              <a:t>28/05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A5048-FCB2-40E4-A0D8-01988A8FF9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25473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574990"/>
            <a:ext cx="7762102" cy="2087455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2647443"/>
            <a:ext cx="3807226" cy="1297471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3944914"/>
            <a:ext cx="3807226" cy="580237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7" y="2647443"/>
            <a:ext cx="3825976" cy="1297471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7" y="3944914"/>
            <a:ext cx="3825976" cy="580237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E4063-BBB1-40F4-A53A-C65A7728EA7C}" type="datetimeFigureOut">
              <a:rPr lang="fr-FR" smtClean="0"/>
              <a:t>28/05/2025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A5048-FCB2-40E4-A0D8-01988A8FF9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068814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E4063-BBB1-40F4-A53A-C65A7728EA7C}" type="datetimeFigureOut">
              <a:rPr lang="fr-FR" smtClean="0"/>
              <a:t>28/05/2025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A5048-FCB2-40E4-A0D8-01988A8FF9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24670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E4063-BBB1-40F4-A53A-C65A7728EA7C}" type="datetimeFigureOut">
              <a:rPr lang="fr-FR" smtClean="0"/>
              <a:t>28/05/2025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A5048-FCB2-40E4-A0D8-01988A8FF9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22691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719984"/>
            <a:ext cx="2902585" cy="2519945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1554968"/>
            <a:ext cx="4556016" cy="7674832"/>
          </a:xfrm>
        </p:spPr>
        <p:txBody>
          <a:bodyPr/>
          <a:lstStyle>
            <a:lvl1pPr>
              <a:defRPr sz="3149"/>
            </a:lvl1pPr>
            <a:lvl2pPr>
              <a:defRPr sz="2756"/>
            </a:lvl2pPr>
            <a:lvl3pPr>
              <a:defRPr sz="2362"/>
            </a:lvl3pPr>
            <a:lvl4pPr>
              <a:defRPr sz="1968"/>
            </a:lvl4pPr>
            <a:lvl5pPr>
              <a:defRPr sz="1968"/>
            </a:lvl5pPr>
            <a:lvl6pPr>
              <a:defRPr sz="1968"/>
            </a:lvl6pPr>
            <a:lvl7pPr>
              <a:defRPr sz="1968"/>
            </a:lvl7pPr>
            <a:lvl8pPr>
              <a:defRPr sz="1968"/>
            </a:lvl8pPr>
            <a:lvl9pPr>
              <a:defRPr sz="1968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3239929"/>
            <a:ext cx="2902585" cy="6002369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E4063-BBB1-40F4-A53A-C65A7728EA7C}" type="datetimeFigureOut">
              <a:rPr lang="fr-FR" smtClean="0"/>
              <a:t>28/05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A5048-FCB2-40E4-A0D8-01988A8FF9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574257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719984"/>
            <a:ext cx="2902585" cy="2519945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1554968"/>
            <a:ext cx="4556016" cy="7674832"/>
          </a:xfrm>
        </p:spPr>
        <p:txBody>
          <a:bodyPr anchor="t"/>
          <a:lstStyle>
            <a:lvl1pPr marL="0" indent="0">
              <a:buNone/>
              <a:defRPr sz="3149"/>
            </a:lvl1pPr>
            <a:lvl2pPr marL="449976" indent="0">
              <a:buNone/>
              <a:defRPr sz="2756"/>
            </a:lvl2pPr>
            <a:lvl3pPr marL="899952" indent="0">
              <a:buNone/>
              <a:defRPr sz="2362"/>
            </a:lvl3pPr>
            <a:lvl4pPr marL="1349929" indent="0">
              <a:buNone/>
              <a:defRPr sz="1968"/>
            </a:lvl4pPr>
            <a:lvl5pPr marL="1799905" indent="0">
              <a:buNone/>
              <a:defRPr sz="1968"/>
            </a:lvl5pPr>
            <a:lvl6pPr marL="2249881" indent="0">
              <a:buNone/>
              <a:defRPr sz="1968"/>
            </a:lvl6pPr>
            <a:lvl7pPr marL="2699857" indent="0">
              <a:buNone/>
              <a:defRPr sz="1968"/>
            </a:lvl7pPr>
            <a:lvl8pPr marL="3149834" indent="0">
              <a:buNone/>
              <a:defRPr sz="1968"/>
            </a:lvl8pPr>
            <a:lvl9pPr marL="3599810" indent="0">
              <a:buNone/>
              <a:defRPr sz="1968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3239929"/>
            <a:ext cx="2902585" cy="6002369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E4063-BBB1-40F4-A53A-C65A7728EA7C}" type="datetimeFigureOut">
              <a:rPr lang="fr-FR" smtClean="0"/>
              <a:t>28/05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A5048-FCB2-40E4-A0D8-01988A8FF9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9371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574990"/>
            <a:ext cx="7762102" cy="2087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2874937"/>
            <a:ext cx="7762102" cy="68523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10009783"/>
            <a:ext cx="2024896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5E4063-BBB1-40F4-A53A-C65A7728EA7C}" type="datetimeFigureOut">
              <a:rPr lang="fr-FR" smtClean="0"/>
              <a:t>28/05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10009783"/>
            <a:ext cx="3037344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10009783"/>
            <a:ext cx="2024896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9A5048-FCB2-40E4-A0D8-01988A8FF9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909655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899952" rtl="0" eaLnBrk="1" latinLnBrk="0" hangingPunct="1">
        <a:lnSpc>
          <a:spcPct val="90000"/>
        </a:lnSpc>
        <a:spcBef>
          <a:spcPct val="0"/>
        </a:spcBef>
        <a:buNone/>
        <a:defRPr sz="43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4988" indent="-224988" algn="l" defTabSz="899952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1pPr>
      <a:lvl2pPr marL="674964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24941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968" kern="1200">
          <a:solidFill>
            <a:schemeClr val="tx1"/>
          </a:solidFill>
          <a:latin typeface="+mn-lt"/>
          <a:ea typeface="+mn-ea"/>
          <a:cs typeface="+mn-cs"/>
        </a:defRPr>
      </a:lvl3pPr>
      <a:lvl4pPr marL="1574917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2024893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474869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924846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374822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824798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1pPr>
      <a:lvl2pPr marL="449976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899952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349929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1799905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249881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699857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149834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59981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CBA83B97-BC6B-4383-BE0A-C0244B19DBE0}"/>
              </a:ext>
            </a:extLst>
          </p:cNvPr>
          <p:cNvSpPr/>
          <p:nvPr/>
        </p:nvSpPr>
        <p:spPr>
          <a:xfrm>
            <a:off x="154254" y="7466332"/>
            <a:ext cx="8875125" cy="2058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sz="738" noProof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2707041A-C27C-446D-999F-1FD2E319FDF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77" t="5512" r="26857" b="13218"/>
          <a:stretch/>
        </p:blipFill>
        <p:spPr>
          <a:xfrm>
            <a:off x="1714375" y="150957"/>
            <a:ext cx="7315004" cy="5561163"/>
          </a:xfrm>
          <a:prstGeom prst="rect">
            <a:avLst/>
          </a:prstGeom>
        </p:spPr>
      </p:pic>
      <p:grpSp>
        <p:nvGrpSpPr>
          <p:cNvPr id="3" name="Groupe 2">
            <a:extLst>
              <a:ext uri="{FF2B5EF4-FFF2-40B4-BE49-F238E27FC236}">
                <a16:creationId xmlns:a16="http://schemas.microsoft.com/office/drawing/2014/main" id="{252CB78C-00A4-4E93-B5D2-82EF967C8D07}"/>
              </a:ext>
            </a:extLst>
          </p:cNvPr>
          <p:cNvGrpSpPr/>
          <p:nvPr/>
        </p:nvGrpSpPr>
        <p:grpSpPr>
          <a:xfrm>
            <a:off x="326038" y="4494053"/>
            <a:ext cx="5662841" cy="6099820"/>
            <a:chOff x="185509" y="4699943"/>
            <a:chExt cx="5199708" cy="4805226"/>
          </a:xfrm>
        </p:grpSpPr>
        <p:pic>
          <p:nvPicPr>
            <p:cNvPr id="5" name="Image 4">
              <a:extLst>
                <a:ext uri="{FF2B5EF4-FFF2-40B4-BE49-F238E27FC236}">
                  <a16:creationId xmlns:a16="http://schemas.microsoft.com/office/drawing/2014/main" id="{AC68135F-1B6D-4EE4-9DB2-4B533B02553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144" r="41602"/>
            <a:stretch/>
          </p:blipFill>
          <p:spPr>
            <a:xfrm>
              <a:off x="185509" y="4699943"/>
              <a:ext cx="5199708" cy="4805226"/>
            </a:xfrm>
            <a:prstGeom prst="rect">
              <a:avLst/>
            </a:prstGeom>
          </p:spPr>
        </p:pic>
        <p:sp>
          <p:nvSpPr>
            <p:cNvPr id="2" name="ZoneTexte 1">
              <a:extLst>
                <a:ext uri="{FF2B5EF4-FFF2-40B4-BE49-F238E27FC236}">
                  <a16:creationId xmlns:a16="http://schemas.microsoft.com/office/drawing/2014/main" id="{B923796B-DF17-4AD8-886E-7D413EEF2AF5}"/>
                </a:ext>
              </a:extLst>
            </p:cNvPr>
            <p:cNvSpPr txBox="1"/>
            <p:nvPr/>
          </p:nvSpPr>
          <p:spPr>
            <a:xfrm>
              <a:off x="3870237" y="8132905"/>
              <a:ext cx="212133" cy="79574"/>
            </a:xfrm>
            <a:prstGeom prst="rect">
              <a:avLst/>
            </a:prstGeom>
            <a:solidFill>
              <a:srgbClr val="FF8F8F"/>
            </a:solidFill>
            <a:ln w="19050">
              <a:solidFill>
                <a:schemeClr val="bg1">
                  <a:lumMod val="50000"/>
                </a:schemeClr>
              </a:solidFill>
              <a:prstDash val="sysDot"/>
            </a:ln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17" b="1" noProof="0" dirty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C8B</a:t>
              </a:r>
            </a:p>
          </p:txBody>
        </p:sp>
      </p:grpSp>
      <p:sp>
        <p:nvSpPr>
          <p:cNvPr id="4" name="Rectangle 3">
            <a:extLst>
              <a:ext uri="{FF2B5EF4-FFF2-40B4-BE49-F238E27FC236}">
                <a16:creationId xmlns:a16="http://schemas.microsoft.com/office/drawing/2014/main" id="{EC7A57AE-4591-4E01-8C98-BC6390E1E29F}"/>
              </a:ext>
            </a:extLst>
          </p:cNvPr>
          <p:cNvSpPr/>
          <p:nvPr/>
        </p:nvSpPr>
        <p:spPr>
          <a:xfrm>
            <a:off x="1988380" y="3314373"/>
            <a:ext cx="790575" cy="257175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noProof="0" dirty="0"/>
              <a:t>Thrombolysis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6EB31101-F8B0-4160-A45B-23B0D8051993}"/>
              </a:ext>
            </a:extLst>
          </p:cNvPr>
          <p:cNvSpPr/>
          <p:nvPr/>
        </p:nvSpPr>
        <p:spPr>
          <a:xfrm>
            <a:off x="1950280" y="1571058"/>
            <a:ext cx="828675" cy="257175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noProof="0" dirty="0"/>
              <a:t>Extrinsic pathway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2BE27EF5-B00D-45C8-8B96-2184444938F4}"/>
              </a:ext>
            </a:extLst>
          </p:cNvPr>
          <p:cNvSpPr/>
          <p:nvPr/>
        </p:nvSpPr>
        <p:spPr>
          <a:xfrm>
            <a:off x="1931230" y="167223"/>
            <a:ext cx="828675" cy="257175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noProof="0" dirty="0"/>
              <a:t>Intrinsic pathway</a:t>
            </a:r>
          </a:p>
        </p:txBody>
      </p:sp>
      <p:sp>
        <p:nvSpPr>
          <p:cNvPr id="7" name="Parenthèse ouvrante 6">
            <a:extLst>
              <a:ext uri="{FF2B5EF4-FFF2-40B4-BE49-F238E27FC236}">
                <a16:creationId xmlns:a16="http://schemas.microsoft.com/office/drawing/2014/main" id="{D62AEBAA-AB0C-49A6-93D7-E56EAFD74972}"/>
              </a:ext>
            </a:extLst>
          </p:cNvPr>
          <p:cNvSpPr/>
          <p:nvPr/>
        </p:nvSpPr>
        <p:spPr>
          <a:xfrm>
            <a:off x="1423905" y="150957"/>
            <a:ext cx="76200" cy="4343096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noProof="0" dirty="0"/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958D3384-5AAE-4777-AA4E-9BA5226E96B1}"/>
              </a:ext>
            </a:extLst>
          </p:cNvPr>
          <p:cNvSpPr txBox="1"/>
          <p:nvPr/>
        </p:nvSpPr>
        <p:spPr>
          <a:xfrm rot="16200000">
            <a:off x="-666123" y="1883558"/>
            <a:ext cx="37882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b="1" noProof="0" dirty="0">
                <a:latin typeface="Arial" panose="020B0604020202020204" pitchFamily="34" charset="0"/>
                <a:cs typeface="Arial" panose="020B0604020202020204" pitchFamily="34" charset="0"/>
              </a:rPr>
              <a:t>blood clotting cascade (WP272</a:t>
            </a:r>
            <a:r>
              <a:rPr lang="en-US" sz="1800" b="1" i="1" noProof="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800" b="1" noProof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b="1" noProof="0" dirty="0"/>
          </a:p>
        </p:txBody>
      </p:sp>
      <p:sp>
        <p:nvSpPr>
          <p:cNvPr id="18" name="Parenthèse ouvrante 17">
            <a:extLst>
              <a:ext uri="{FF2B5EF4-FFF2-40B4-BE49-F238E27FC236}">
                <a16:creationId xmlns:a16="http://schemas.microsoft.com/office/drawing/2014/main" id="{14C30651-184A-4D2B-95F8-D4B4BA7FAEE8}"/>
              </a:ext>
            </a:extLst>
          </p:cNvPr>
          <p:cNvSpPr/>
          <p:nvPr/>
        </p:nvSpPr>
        <p:spPr>
          <a:xfrm>
            <a:off x="340454" y="4643130"/>
            <a:ext cx="76200" cy="6084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noProof="0" dirty="0"/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0B2FB6AB-E7F6-454B-96F9-24B1ACFF8A79}"/>
              </a:ext>
            </a:extLst>
          </p:cNvPr>
          <p:cNvSpPr txBox="1"/>
          <p:nvPr/>
        </p:nvSpPr>
        <p:spPr>
          <a:xfrm rot="16200000">
            <a:off x="-2646657" y="7250254"/>
            <a:ext cx="55835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b="1" noProof="0" dirty="0">
                <a:latin typeface="Arial" panose="020B0604020202020204" pitchFamily="34" charset="0"/>
                <a:cs typeface="Arial" panose="020B0604020202020204" pitchFamily="34" charset="0"/>
              </a:rPr>
              <a:t>complement and coagulation cascades (WP558</a:t>
            </a:r>
            <a:r>
              <a:rPr lang="en-US" sz="1800" b="1" i="1" noProof="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800" b="1" noProof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b="1" noProof="0" dirty="0"/>
          </a:p>
        </p:txBody>
      </p:sp>
    </p:spTree>
    <p:extLst>
      <p:ext uri="{BB962C8B-B14F-4D97-AF65-F5344CB8AC3E}">
        <p14:creationId xmlns:p14="http://schemas.microsoft.com/office/powerpoint/2010/main" val="259067673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88</TotalTime>
  <Words>105</Words>
  <Application>Microsoft Office PowerPoint</Application>
  <PresentationFormat>Personnalisé</PresentationFormat>
  <Paragraphs>8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oteome ATTR /IC/AL</dc:title>
  <dc:creator>amira zaroui</dc:creator>
  <cp:lastModifiedBy>SANDRINE BOURGOIN</cp:lastModifiedBy>
  <cp:revision>69</cp:revision>
  <dcterms:created xsi:type="dcterms:W3CDTF">2023-10-15T17:41:01Z</dcterms:created>
  <dcterms:modified xsi:type="dcterms:W3CDTF">2025-05-28T08:25:45Z</dcterms:modified>
</cp:coreProperties>
</file>